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0" r:id="rId3"/>
    <p:sldId id="259" r:id="rId4"/>
    <p:sldId id="25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B1F67C-3B8E-A6B6-191C-45EE9DB5F56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CA5BCAC-28DD-838B-FFD0-753C23E358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E7FF20-7402-E412-BB93-A8E53FC783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C98B3-AD0B-401B-A659-5C7E5540C50A}" type="datetimeFigureOut">
              <a:rPr lang="en-US" smtClean="0"/>
              <a:t>7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16DDC2-D25B-9F4C-0E4C-55421A95AA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BEC9E0-6AF7-3C7B-172A-6130AB8E0D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4BA85-7531-4777-A4E8-0BBE54DBC0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45765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890701-1E4F-F1F6-B6EF-C19A9F2B03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DADD6E-DED6-FB10-EA8C-540C78A1FA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C5E263-2576-31BE-92A6-CD7939E04D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C98B3-AD0B-401B-A659-5C7E5540C50A}" type="datetimeFigureOut">
              <a:rPr lang="en-US" smtClean="0"/>
              <a:t>7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D3A5AB-4065-C533-D52E-2E2427A2CA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9AF7BB-E6D6-F3E7-6FD5-3C9E1E5AC6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4BA85-7531-4777-A4E8-0BBE54DBC0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56211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F04B50D-4E77-095A-E03C-1C267D64832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624BF5-CE38-0D34-AED1-5EF44D2900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2A4529-3E68-CCA5-0211-C642DAB1DC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C98B3-AD0B-401B-A659-5C7E5540C50A}" type="datetimeFigureOut">
              <a:rPr lang="en-US" smtClean="0"/>
              <a:t>7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A2953C-0F65-B220-37F3-F07D004483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4F0391-BC82-D92D-8305-2EF1C3C169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4BA85-7531-4777-A4E8-0BBE54DBC0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82448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69A82F-B66C-4136-4029-298143FAF8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92F9FB-27FF-ACD0-32A5-E1EC2848D28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F63C21-B5FD-249F-27F6-DF67F590C3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C98B3-AD0B-401B-A659-5C7E5540C50A}" type="datetimeFigureOut">
              <a:rPr lang="en-US" smtClean="0"/>
              <a:t>7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F538B9-859D-2CFD-DC0F-20162EE443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DC674A-AE26-4FD1-CDFF-858BBDCC63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4BA85-7531-4777-A4E8-0BBE54DBC0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1711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DFD97D-803F-FD87-E612-1D646BC69C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A27B30-0D10-8119-3843-EC321A5677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BBBA15-B548-A229-8A4D-7B41A3FDA5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C98B3-AD0B-401B-A659-5C7E5540C50A}" type="datetimeFigureOut">
              <a:rPr lang="en-US" smtClean="0"/>
              <a:t>7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A5B168-FD1D-9953-B48D-B057CE468D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2BA45E-C690-94DE-5270-0650FFF310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4BA85-7531-4777-A4E8-0BBE54DBC0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7930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454390-3EC0-E5B0-980B-D4C2477867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3E2732-E5B2-F1F8-548E-E0682F78F1E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0C86E19-4F72-D727-FCC6-A31616B32A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C936B51-8613-C3A8-1102-7A00F2990A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C98B3-AD0B-401B-A659-5C7E5540C50A}" type="datetimeFigureOut">
              <a:rPr lang="en-US" smtClean="0"/>
              <a:t>7/1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B0DF03-14B8-BC1B-3E8C-C2EDEFFE5C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8C755D-0B2A-8E20-9988-D3413A1D35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4BA85-7531-4777-A4E8-0BBE54DBC0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04689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3D0D54-C373-CF07-53FF-F0A285C316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86A0CED-3F9C-9F36-03AF-2480DC8F37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0899D3-9ACE-6AED-C953-B227C2A309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084F919-7835-7EDC-CDC3-F10D2F9B3DE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72A4592-854C-DB7D-9389-1A8CB648E6A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5A5C310-5C15-DB44-81B2-98D86B5454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C98B3-AD0B-401B-A659-5C7E5540C50A}" type="datetimeFigureOut">
              <a:rPr lang="en-US" smtClean="0"/>
              <a:t>7/16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33FD057-7DDA-F36D-CF66-6ACCB875EB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A50AB25-9867-1C7A-725A-B4381FEDD2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4BA85-7531-4777-A4E8-0BBE54DBC0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99334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6BEF81-90AF-0E93-51A1-2312FF69F5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65E51D3-6267-3D48-619D-53A66367F3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C98B3-AD0B-401B-A659-5C7E5540C50A}" type="datetimeFigureOut">
              <a:rPr lang="en-US" smtClean="0"/>
              <a:t>7/16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F1AE1AF-2181-D429-7A6F-2FB8E3E34B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3AD3065-EF26-CAA9-0BC1-9A1248DFCE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4BA85-7531-4777-A4E8-0BBE54DBC0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0946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B967504-322C-8538-2692-08F0A02C78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C98B3-AD0B-401B-A659-5C7E5540C50A}" type="datetimeFigureOut">
              <a:rPr lang="en-US" smtClean="0"/>
              <a:t>7/16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8E64B87-CA3A-0E98-8556-C19D7EF933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CB1DC43-11F8-FF8E-A0A0-904013B3FD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4BA85-7531-4777-A4E8-0BBE54DBC0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9384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07C5B5-FCEC-3312-EAC2-6C3B366333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26D117-8033-92E6-4657-D5C1FA019A6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B02B78D-6933-5B27-CA6A-8C55AC3C94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0F0F502-7260-6EE7-954B-CEC3A266A6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C98B3-AD0B-401B-A659-5C7E5540C50A}" type="datetimeFigureOut">
              <a:rPr lang="en-US" smtClean="0"/>
              <a:t>7/1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E6933C1-EB22-66E8-D7E0-D30FB9BA92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16EE5F-8A00-8D86-DDE3-DF26D841A8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4BA85-7531-4777-A4E8-0BBE54DBC0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47022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6F4887-4A97-1230-2BEF-54E90EF3FC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E924486-A341-9540-5864-794D570314A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095E2FF-1915-9F5D-E980-9360D50793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5B1B7A-773D-4C2F-AED3-E71BF2A40C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C98B3-AD0B-401B-A659-5C7E5540C50A}" type="datetimeFigureOut">
              <a:rPr lang="en-US" smtClean="0"/>
              <a:t>7/1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BF91266-B319-7B0F-BDDF-A393050CFF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06B6AB4-A7ED-8330-5EEE-A6272D02CC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4BA85-7531-4777-A4E8-0BBE54DBC0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4370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A20E026-475E-DAA3-7879-FDCBFBEC77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61485AB-EABE-24B0-4332-27BA56BCB9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257B0E-5792-6C13-EED9-B26D037271A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4C98B3-AD0B-401B-A659-5C7E5540C50A}" type="datetimeFigureOut">
              <a:rPr lang="en-US" smtClean="0"/>
              <a:t>7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85B8BE-C321-0933-FA07-5A1FB733834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6CEDF0-1822-430C-773A-5074E9ACB4A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D4BA85-7531-4777-A4E8-0BBE54DBC0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11345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Content Placeholder 8">
            <a:extLst>
              <a:ext uri="{FF2B5EF4-FFF2-40B4-BE49-F238E27FC236}">
                <a16:creationId xmlns:a16="http://schemas.microsoft.com/office/drawing/2014/main" id="{D879DE6C-8CE2-4CAC-82C3-EBBE4F067CA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782" y="595130"/>
            <a:ext cx="4254159" cy="6262870"/>
          </a:xfr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C810663D-FCA3-DEBA-B9AA-564DBF7D7C07}"/>
              </a:ext>
            </a:extLst>
          </p:cNvPr>
          <p:cNvSpPr txBox="1"/>
          <p:nvPr/>
        </p:nvSpPr>
        <p:spPr>
          <a:xfrm>
            <a:off x="318782" y="158685"/>
            <a:ext cx="31207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/>
              <a:t>SlPLATZ2 </a:t>
            </a:r>
            <a:r>
              <a:rPr lang="en-US" dirty="0"/>
              <a:t>and </a:t>
            </a:r>
            <a:r>
              <a:rPr lang="en-US" i="1" dirty="0"/>
              <a:t>SlPLATZ10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49E78281-8BCB-0D69-91C5-49853462BA2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4637" y="640080"/>
            <a:ext cx="5332103" cy="621792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89D6230D-2609-9BF2-72A5-DB74326A3F68}"/>
              </a:ext>
            </a:extLst>
          </p:cNvPr>
          <p:cNvSpPr txBox="1"/>
          <p:nvPr/>
        </p:nvSpPr>
        <p:spPr>
          <a:xfrm>
            <a:off x="4934125" y="158685"/>
            <a:ext cx="31207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/>
              <a:t>SlPLATZ3 </a:t>
            </a:r>
            <a:r>
              <a:rPr lang="en-US" dirty="0"/>
              <a:t>and </a:t>
            </a:r>
            <a:r>
              <a:rPr lang="en-US" i="1" dirty="0"/>
              <a:t>SlPLATZ4</a:t>
            </a:r>
          </a:p>
        </p:txBody>
      </p:sp>
    </p:spTree>
    <p:extLst>
      <p:ext uri="{BB962C8B-B14F-4D97-AF65-F5344CB8AC3E}">
        <p14:creationId xmlns:p14="http://schemas.microsoft.com/office/powerpoint/2010/main" val="23943052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873DEFA-7432-46FB-6AD7-FB82DF90578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74" y="375995"/>
            <a:ext cx="5884814" cy="648200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17EDA26E-64FF-F71C-86FC-73544FB85CF4}"/>
              </a:ext>
            </a:extLst>
          </p:cNvPr>
          <p:cNvSpPr txBox="1"/>
          <p:nvPr/>
        </p:nvSpPr>
        <p:spPr>
          <a:xfrm>
            <a:off x="144074" y="0"/>
            <a:ext cx="31207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/>
              <a:t>SlPLATZ6 </a:t>
            </a:r>
            <a:r>
              <a:rPr lang="en-US" dirty="0"/>
              <a:t>and </a:t>
            </a:r>
            <a:r>
              <a:rPr lang="en-US" i="1" dirty="0"/>
              <a:t>SlPLATZ7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C228F2E3-EB42-6BCE-AB18-FEBB0423F0A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38096" y="362669"/>
            <a:ext cx="4578254" cy="6488668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42983FE0-9ABF-C96E-A972-08CA747C298B}"/>
              </a:ext>
            </a:extLst>
          </p:cNvPr>
          <p:cNvSpPr txBox="1"/>
          <p:nvPr/>
        </p:nvSpPr>
        <p:spPr>
          <a:xfrm>
            <a:off x="6604995" y="-15052"/>
            <a:ext cx="31207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/>
              <a:t>SlPLATZ8 </a:t>
            </a:r>
            <a:r>
              <a:rPr lang="en-US" dirty="0"/>
              <a:t>and </a:t>
            </a:r>
            <a:r>
              <a:rPr lang="en-US" i="1" dirty="0"/>
              <a:t>SlPLATZ9</a:t>
            </a:r>
          </a:p>
        </p:txBody>
      </p:sp>
    </p:spTree>
    <p:extLst>
      <p:ext uri="{BB962C8B-B14F-4D97-AF65-F5344CB8AC3E}">
        <p14:creationId xmlns:p14="http://schemas.microsoft.com/office/powerpoint/2010/main" val="41420010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4EF91C22-0233-7974-64D3-2836A546208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860" y="337397"/>
            <a:ext cx="4607699" cy="6451289"/>
          </a:xfr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44E91E40-8357-2CCF-63B6-639CD824C067}"/>
              </a:ext>
            </a:extLst>
          </p:cNvPr>
          <p:cNvSpPr txBox="1"/>
          <p:nvPr/>
        </p:nvSpPr>
        <p:spPr>
          <a:xfrm>
            <a:off x="299860" y="-31935"/>
            <a:ext cx="31207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/>
              <a:t>SlPLATZ18 </a:t>
            </a:r>
            <a:r>
              <a:rPr lang="en-US" dirty="0"/>
              <a:t>and </a:t>
            </a:r>
            <a:r>
              <a:rPr lang="en-US" i="1" dirty="0"/>
              <a:t>SlPLATZ13</a:t>
            </a:r>
          </a:p>
        </p:txBody>
      </p:sp>
      <p:pic>
        <p:nvPicPr>
          <p:cNvPr id="4" name="Content Placeholder 4">
            <a:extLst>
              <a:ext uri="{FF2B5EF4-FFF2-40B4-BE49-F238E27FC236}">
                <a16:creationId xmlns:a16="http://schemas.microsoft.com/office/drawing/2014/main" id="{486A4BB8-BF57-0115-1DC5-92239240108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809"/>
          <a:stretch/>
        </p:blipFill>
        <p:spPr>
          <a:xfrm>
            <a:off x="5198153" y="368723"/>
            <a:ext cx="5528866" cy="639280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3F87F12-5292-8C40-2966-24E4B5059DDB}"/>
              </a:ext>
            </a:extLst>
          </p:cNvPr>
          <p:cNvSpPr txBox="1"/>
          <p:nvPr/>
        </p:nvSpPr>
        <p:spPr>
          <a:xfrm>
            <a:off x="5198153" y="0"/>
            <a:ext cx="31207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/>
              <a:t>SlPLATZ15 </a:t>
            </a:r>
            <a:r>
              <a:rPr lang="en-US" dirty="0"/>
              <a:t>and </a:t>
            </a:r>
            <a:r>
              <a:rPr lang="en-US" i="1" dirty="0"/>
              <a:t>SlPLATZ16</a:t>
            </a:r>
          </a:p>
        </p:txBody>
      </p:sp>
    </p:spTree>
    <p:extLst>
      <p:ext uri="{BB962C8B-B14F-4D97-AF65-F5344CB8AC3E}">
        <p14:creationId xmlns:p14="http://schemas.microsoft.com/office/powerpoint/2010/main" val="13802490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31552701-8E97-4692-2AC2-1B0851A5EBD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427" y="465195"/>
            <a:ext cx="5528866" cy="6392805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5882D5D8-ACC0-75A4-CE1A-3C8FA8B6E79A}"/>
              </a:ext>
            </a:extLst>
          </p:cNvPr>
          <p:cNvSpPr txBox="1"/>
          <p:nvPr/>
        </p:nvSpPr>
        <p:spPr>
          <a:xfrm>
            <a:off x="131427" y="95863"/>
            <a:ext cx="31207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/>
              <a:t>SlPLATZ17 </a:t>
            </a:r>
            <a:r>
              <a:rPr lang="en-US" dirty="0"/>
              <a:t>and </a:t>
            </a:r>
            <a:r>
              <a:rPr lang="en-US" i="1" dirty="0"/>
              <a:t>SlPLATZ18</a:t>
            </a:r>
          </a:p>
        </p:txBody>
      </p:sp>
    </p:spTree>
    <p:extLst>
      <p:ext uri="{BB962C8B-B14F-4D97-AF65-F5344CB8AC3E}">
        <p14:creationId xmlns:p14="http://schemas.microsoft.com/office/powerpoint/2010/main" val="26182734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4</TotalTime>
  <Words>21</Words>
  <Application>Microsoft Office PowerPoint</Application>
  <PresentationFormat>Widescreen</PresentationFormat>
  <Paragraphs>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p</dc:creator>
  <cp:lastModifiedBy>hp</cp:lastModifiedBy>
  <cp:revision>1</cp:revision>
  <dcterms:created xsi:type="dcterms:W3CDTF">2022-07-15T11:00:40Z</dcterms:created>
  <dcterms:modified xsi:type="dcterms:W3CDTF">2022-07-16T12:18:53Z</dcterms:modified>
</cp:coreProperties>
</file>